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25" d="100"/>
          <a:sy n="125" d="100"/>
        </p:scale>
        <p:origin x="-3156" y="-91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80050681-A6E7-CB34-776C-A39448932E3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Подзаголовок 2">
            <a:extLst>
              <a:ext uri="{FF2B5EF4-FFF2-40B4-BE49-F238E27FC236}">
                <a16:creationId xmlns="" xmlns:a16="http://schemas.microsoft.com/office/drawing/2014/main" id="{B72927D1-72F9-3937-65BB-BC2D5CF3D89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/>
              <a:t>Образец подзаголовка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B7FFD7E8-8911-5351-E2CE-F6E43811AC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C65C6ADA-DF1A-22A7-389D-48B49E826E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9286EA4A-99FC-AE9D-E08A-9E6BCE41D4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168078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FE70942C-1F5F-C0B1-C660-EED1689FAD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>
            <a:extLst>
              <a:ext uri="{FF2B5EF4-FFF2-40B4-BE49-F238E27FC236}">
                <a16:creationId xmlns="" xmlns:a16="http://schemas.microsoft.com/office/drawing/2014/main" id="{F7A6F098-3AE5-49DF-F65D-2343EEB7FF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019F7976-9D0C-EDD2-4C13-A76724BDD3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43F07E5B-6C33-5E41-A73F-960A50586A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C5416937-6BAF-D56B-AC22-EFFC83807C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160416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>
            <a:extLst>
              <a:ext uri="{FF2B5EF4-FFF2-40B4-BE49-F238E27FC236}">
                <a16:creationId xmlns="" xmlns:a16="http://schemas.microsoft.com/office/drawing/2014/main" id="{8AEBD049-29D2-C7E4-0FA7-4CB5B0E9256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>
            <a:extLst>
              <a:ext uri="{FF2B5EF4-FFF2-40B4-BE49-F238E27FC236}">
                <a16:creationId xmlns="" xmlns:a16="http://schemas.microsoft.com/office/drawing/2014/main" id="{81775499-822A-1621-FF9C-9541677513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842DCA56-F96C-1D02-23A3-952C52C6B9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7C23E8F8-3995-5AA5-E538-1D7767F579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681A1687-6E0E-B5A1-1E47-BDB5D55E32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2967918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4D8AFF0F-5700-B26D-6510-E4B5812521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="" xmlns:a16="http://schemas.microsoft.com/office/drawing/2014/main" id="{C2616D5E-F700-2C5B-2525-D9ABBA32FAF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7B6F5DD9-7D53-1F8E-F8AB-03C3596A05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BEF23A49-E9C4-4C96-6225-E9A89D9619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7A5B151E-E8EA-32ED-F282-DB4295BCCE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267756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4FAC267D-330B-F6AF-4194-8CB242E89D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="" xmlns:a16="http://schemas.microsoft.com/office/drawing/2014/main" id="{CEC20DB7-BF07-D2EB-CBEE-8BEF5DA202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D2D12727-0D8C-0D98-E2D9-8D5A8DB92A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D72BD71C-EDB5-6022-A4E0-4B39979716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C720F283-4064-E1C7-CA01-158A50CBF9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7910777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28696025-4BA6-501D-A54D-573AA70F53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="" xmlns:a16="http://schemas.microsoft.com/office/drawing/2014/main" id="{6593ACB2-7908-2D5F-7A5A-67103E6F22A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Объект 3">
            <a:extLst>
              <a:ext uri="{FF2B5EF4-FFF2-40B4-BE49-F238E27FC236}">
                <a16:creationId xmlns="" xmlns:a16="http://schemas.microsoft.com/office/drawing/2014/main" id="{39B666E6-8B5D-4A84-E584-76E0313E900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="" xmlns:a16="http://schemas.microsoft.com/office/drawing/2014/main" id="{E18E3FE3-CE0E-6BBE-1373-B4FF91DB95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="" xmlns:a16="http://schemas.microsoft.com/office/drawing/2014/main" id="{D6B99DBB-D291-B70F-51C5-6DCDC658DE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="" xmlns:a16="http://schemas.microsoft.com/office/drawing/2014/main" id="{F0A93378-1089-DAD4-CBF2-5E2FC5DF56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732500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A6820180-2B1F-7E86-1C85-028489FD29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="" xmlns:a16="http://schemas.microsoft.com/office/drawing/2014/main" id="{EEA8BD1E-7645-FAF4-9F72-EF8F78D4F7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Объект 3">
            <a:extLst>
              <a:ext uri="{FF2B5EF4-FFF2-40B4-BE49-F238E27FC236}">
                <a16:creationId xmlns="" xmlns:a16="http://schemas.microsoft.com/office/drawing/2014/main" id="{E92BEE2D-3AFB-C625-6DE2-8C76C27EB4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Текст 4">
            <a:extLst>
              <a:ext uri="{FF2B5EF4-FFF2-40B4-BE49-F238E27FC236}">
                <a16:creationId xmlns="" xmlns:a16="http://schemas.microsoft.com/office/drawing/2014/main" id="{D48BAEFA-4424-02C9-EB89-03A28F2BCDF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Объект 5">
            <a:extLst>
              <a:ext uri="{FF2B5EF4-FFF2-40B4-BE49-F238E27FC236}">
                <a16:creationId xmlns="" xmlns:a16="http://schemas.microsoft.com/office/drawing/2014/main" id="{15C41A3B-AA13-F21F-B349-2478C82EDEF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7" name="Дата 6">
            <a:extLst>
              <a:ext uri="{FF2B5EF4-FFF2-40B4-BE49-F238E27FC236}">
                <a16:creationId xmlns="" xmlns:a16="http://schemas.microsoft.com/office/drawing/2014/main" id="{F0582415-56DC-B170-CDF0-BE62EFA9A5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8" name="Нижний колонтитул 7">
            <a:extLst>
              <a:ext uri="{FF2B5EF4-FFF2-40B4-BE49-F238E27FC236}">
                <a16:creationId xmlns="" xmlns:a16="http://schemas.microsoft.com/office/drawing/2014/main" id="{9D6EFAC7-B063-911F-7F4E-3F19049E3C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>
            <a:extLst>
              <a:ext uri="{FF2B5EF4-FFF2-40B4-BE49-F238E27FC236}">
                <a16:creationId xmlns="" xmlns:a16="http://schemas.microsoft.com/office/drawing/2014/main" id="{8615E53A-1EF6-4E23-2F17-469E4F077D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308927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FE3B1CE2-671B-89DF-FD96-BF399AC6C4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Дата 2">
            <a:extLst>
              <a:ext uri="{FF2B5EF4-FFF2-40B4-BE49-F238E27FC236}">
                <a16:creationId xmlns="" xmlns:a16="http://schemas.microsoft.com/office/drawing/2014/main" id="{CD966B3B-14C6-4C2A-8BCF-5AC15AF6A4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4" name="Нижний колонтитул 3">
            <a:extLst>
              <a:ext uri="{FF2B5EF4-FFF2-40B4-BE49-F238E27FC236}">
                <a16:creationId xmlns="" xmlns:a16="http://schemas.microsoft.com/office/drawing/2014/main" id="{61EE871A-067C-4449-D4D3-F240132B7A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>
            <a:extLst>
              <a:ext uri="{FF2B5EF4-FFF2-40B4-BE49-F238E27FC236}">
                <a16:creationId xmlns="" xmlns:a16="http://schemas.microsoft.com/office/drawing/2014/main" id="{2A2DFCB0-E29A-AD2B-14A6-DCD6F79FDE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0125285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>
            <a:extLst>
              <a:ext uri="{FF2B5EF4-FFF2-40B4-BE49-F238E27FC236}">
                <a16:creationId xmlns="" xmlns:a16="http://schemas.microsoft.com/office/drawing/2014/main" id="{B326F172-39F4-44FD-B858-0F4FEDB344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3" name="Нижний колонтитул 2">
            <a:extLst>
              <a:ext uri="{FF2B5EF4-FFF2-40B4-BE49-F238E27FC236}">
                <a16:creationId xmlns="" xmlns:a16="http://schemas.microsoft.com/office/drawing/2014/main" id="{843C5D89-BAEB-7FB1-8323-6A4F11E545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>
            <a:extLst>
              <a:ext uri="{FF2B5EF4-FFF2-40B4-BE49-F238E27FC236}">
                <a16:creationId xmlns="" xmlns:a16="http://schemas.microsoft.com/office/drawing/2014/main" id="{1D54F48A-EF69-D74B-2200-1351DE33D6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8117553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FE32B685-E62F-17A9-476C-E140148065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="" xmlns:a16="http://schemas.microsoft.com/office/drawing/2014/main" id="{BD605308-4383-0779-8E55-0E3B027A4EA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Текст 3">
            <a:extLst>
              <a:ext uri="{FF2B5EF4-FFF2-40B4-BE49-F238E27FC236}">
                <a16:creationId xmlns="" xmlns:a16="http://schemas.microsoft.com/office/drawing/2014/main" id="{7A7238C4-3A51-1C78-931B-E7B7374248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="" xmlns:a16="http://schemas.microsoft.com/office/drawing/2014/main" id="{CE62676F-B03B-3404-BCF7-7B822770B0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="" xmlns:a16="http://schemas.microsoft.com/office/drawing/2014/main" id="{889DEF69-5A9D-EEB3-C2A4-12A9C7E14D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="" xmlns:a16="http://schemas.microsoft.com/office/drawing/2014/main" id="{FEB9A95A-8412-41DC-FA9A-3C907742CE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5765011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C0C8E5B2-EBF3-EF94-A6C4-A37CD31B5E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Рисунок 2">
            <a:extLst>
              <a:ext uri="{FF2B5EF4-FFF2-40B4-BE49-F238E27FC236}">
                <a16:creationId xmlns="" xmlns:a16="http://schemas.microsoft.com/office/drawing/2014/main" id="{67A90359-6F91-3B96-CED3-CF304C4EC6B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>
            <a:extLst>
              <a:ext uri="{FF2B5EF4-FFF2-40B4-BE49-F238E27FC236}">
                <a16:creationId xmlns="" xmlns:a16="http://schemas.microsoft.com/office/drawing/2014/main" id="{A387EA31-F8C7-732C-072D-3497177640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="" xmlns:a16="http://schemas.microsoft.com/office/drawing/2014/main" id="{8147160C-4191-6406-5182-FCE5EE9E01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="" xmlns:a16="http://schemas.microsoft.com/office/drawing/2014/main" id="{FAAAC055-D406-0213-2907-8A8DFC6845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="" xmlns:a16="http://schemas.microsoft.com/office/drawing/2014/main" id="{94D46E60-6FCF-8EBF-1455-9BA07E3D9A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43807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2F918E65-B4F6-4D4B-15CA-EB4E976DC2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="" xmlns:a16="http://schemas.microsoft.com/office/drawing/2014/main" id="{D3EE80B9-9D15-32B0-2C6B-B0B4CBC751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7F19557F-66E9-9344-74A8-C96C42B1846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A93133E5-9E8B-012A-757F-3101932A86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8FEEC80B-B08C-A809-F323-54607FFDD1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4569319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54D09361-B79C-DFC0-0777-9FBA893FAA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5437" y="99951"/>
            <a:ext cx="8923783" cy="476123"/>
          </a:xfrm>
        </p:spPr>
        <p:txBody>
          <a:bodyPr>
            <a:normAutofit fontScale="90000"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Differential expressed genes that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howed enhancing effects of at least one of the peptides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max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ACTH(6-9)PGP) on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he effect of ischemia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tself in the region of frontal cortex (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C)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 24 h after </a:t>
            </a:r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MCAO</a:t>
            </a:r>
            <a:r>
              <a:rPr lang="ru-RU" sz="14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="" xmlns:a16="http://schemas.microsoft.com/office/drawing/2014/main" id="{B5A1926C-F1CF-5BDA-0061-F4962B0CECD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55448" y="5943600"/>
            <a:ext cx="8862822" cy="576073"/>
          </a:xfrm>
        </p:spPr>
        <p:txBody>
          <a:bodyPr>
            <a:normAutofit fontScale="92500" lnSpcReduction="10000"/>
          </a:bodyPr>
          <a:lstStyle/>
          <a:p>
            <a:pPr marL="0" indent="0">
              <a:buNone/>
            </a:pP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Hierarchical cluster analysis of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EGs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n IR24-f vs. SO24-f, IS24-f vs. IR24-f, IA24-f vs. IR24-f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where each row represents a DEG; n = 3 per group. Only those genes with cut-off &gt;1.5 and </a:t>
            </a:r>
            <a:r>
              <a:rPr lang="en-US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Padj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&lt; 0.05 were selected as significant results.</a:t>
            </a:r>
            <a:endParaRPr lang="ru-RU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9" name="Picture 5" descr="K:\Редактируемые\Для публикаций\0_текущие публикации\ишемия_2\кора\статья по 24 часам DRFC\fs3-1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165" y="1175383"/>
            <a:ext cx="8548962" cy="412051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2803779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4</TotalTime>
  <Words>94</Words>
  <Application>Microsoft Office PowerPoint</Application>
  <PresentationFormat>Экран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Figure S4. Differential expressed genes that showed enhancing effects of at least one of the peptides (Semax, ACTH(6-9)PGP) on the effect of ischemia itself in the region of frontal cortex (FC) at 24 h after tMCAO.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S1. Real-time reverse transcription polymerase chain reaction (RT-PCR) verification of the RNA-Seq results.</dc:title>
  <dc:creator>Maria Manor</dc:creator>
  <cp:lastModifiedBy>Ivan</cp:lastModifiedBy>
  <cp:revision>11</cp:revision>
  <dcterms:created xsi:type="dcterms:W3CDTF">2023-01-16T11:00:34Z</dcterms:created>
  <dcterms:modified xsi:type="dcterms:W3CDTF">2024-11-11T09:00:42Z</dcterms:modified>
</cp:coreProperties>
</file>